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69" r:id="rId1"/>
  </p:sldMasterIdLst>
  <p:notesMasterIdLst>
    <p:notesMasterId r:id="rId3"/>
  </p:notes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  <a:srgbClr val="AC04A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613" autoAdjust="0"/>
    <p:restoredTop sz="96357" autoAdjust="0"/>
  </p:normalViewPr>
  <p:slideViewPr>
    <p:cSldViewPr snapToGrid="0">
      <p:cViewPr varScale="1">
        <p:scale>
          <a:sx n="110" d="100"/>
          <a:sy n="110" d="100"/>
        </p:scale>
        <p:origin x="858" y="108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-8946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7FADA1F-E3BC-4FBA-88AF-198F841D33CB}" type="datetimeFigureOut">
              <a:rPr lang="en-US" smtClean="0"/>
              <a:t>5/22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595147-72AB-4248-BBAB-5E4406E5A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8741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5595147-72AB-4248-BBAB-5E4406E5A5B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4462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E1FBB8-A4B3-C911-282E-288DCEB3F6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554BCDE-DEB7-45E1-6AB9-DD2F4032088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6F5D1A-D6D3-9FFF-F892-08169F1611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4A43C-5F78-42C3-A9D9-8D8C84DBC6BB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8BC313-35F6-2E02-D682-F1DE971ABD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50F404-9187-AD1E-98AE-A43359E8DD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075670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05899F-8155-4185-27E4-A57F9ACAAD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288FDF-BEE4-CCBE-ED1C-133DCF7CEA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F11AAE-C5CE-23B0-4309-127800C0A8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89718-1F9A-4C1F-93AE-5036A61C958C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8B48E7-9710-4BA1-4D9F-64D15F1952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579CAB-2F46-843B-2664-C519744230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67491369"/>
      </p:ext>
    </p:extLst>
  </p:cSld>
  <p:clrMapOvr>
    <a:masterClrMapping/>
  </p:clrMapOvr>
  <p:hf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F5222BC-7327-14B4-AAA8-BBA7F04B56F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60D97C-7782-DB84-4C83-ACE3AD5BE3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63DD37-5EB6-8D87-E94C-1C7F178EB7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89718-1F9A-4C1F-93AE-5036A61C958C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C0CBD8-A8AA-2EAB-B7B7-AB81E43212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E5D7DA-5A95-49F9-A976-52F570165C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00604011"/>
      </p:ext>
    </p:extLst>
  </p:cSld>
  <p:clrMapOvr>
    <a:masterClrMapping/>
  </p:clrMapOvr>
  <p:hf hdr="0" ftr="0" dt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2" name="Content Placeholder 2"/>
          <p:cNvSpPr>
            <a:spLocks noGrp="1"/>
          </p:cNvSpPr>
          <p:nvPr>
            <p:ph sz="quarter" idx="13"/>
          </p:nvPr>
        </p:nvSpPr>
        <p:spPr>
          <a:xfrm>
            <a:off x="913774" y="2367092"/>
            <a:ext cx="10363826" cy="342410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CDD2C-E9B4-482E-8541-515E1D30D294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686313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1E5D1A-BAD8-4456-F2C8-44A66832E8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E0189A-AC6D-E868-768C-98106727B83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2D974E-F2A6-4014-FCE2-5D1A2D7A3A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89718-1F9A-4C1F-93AE-5036A61C958C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71EB5C-1CE6-B095-A273-650D46700B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499060-9BAD-FBD6-2FC4-760FA1A705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96466044"/>
      </p:ext>
    </p:extLst>
  </p:cSld>
  <p:clrMapOvr>
    <a:masterClrMapping/>
  </p:clrMapOvr>
  <p:hf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EB746F-E692-9185-F746-C801F2CD65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1B4601-1A97-1EE9-E592-7FA3D9F20B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8E1E9F-6710-FFC1-3FDC-BA9A3D8B7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B666A-4E7A-48EA-8A44-3F8E3611875F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BB47AC-700C-970C-CC8E-CE72D291E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3020EA-399C-614E-AC9A-20BBD6D777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730171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B81270-4FD5-1252-1D3D-6E10D59189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240679-5D4E-4436-5821-37EA38A8A4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30C4010-5959-C407-BD09-0437D74B15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A57B6C-F185-D701-68DB-F341B7A75D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89718-1F9A-4C1F-93AE-5036A61C958C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F72880-82FA-6C5C-3FB5-742A68EFD1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47D986-87AA-3EA3-82C6-055D4BE09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87710203"/>
      </p:ext>
    </p:extLst>
  </p:cSld>
  <p:clrMapOvr>
    <a:masterClrMapping/>
  </p:clrMapOvr>
  <p:hf hdr="0" ft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25547F-5EBD-4911-123B-B80AD80D8B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3BA6EA-1259-F77A-C1C8-86A5B7C17A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2729D9A-3357-2D57-C9A4-E57B47394B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7A25AA3-5730-7E74-268D-7F40F9ADCB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05792ED-E34B-3BEE-9C0E-0C20D9B38E8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8DECA0E-D1D7-29B8-EF10-C69623E104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89718-1F9A-4C1F-93AE-5036A61C958C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4B06D4A-62C7-0D3F-8739-873ADC0523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9B117C6-D9E2-9FA6-E22B-5B45E25B75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54017889"/>
      </p:ext>
    </p:extLst>
  </p:cSld>
  <p:clrMapOvr>
    <a:masterClrMapping/>
  </p:clrMapOvr>
  <p:hf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D8D869-5D36-050D-7D33-2EB67CA330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0F1C4B5-B8BC-F284-19FF-1040F41DE9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AAFE7-52D9-4E4C-BA8B-C574D5A0971B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38DBEBD-28B6-DA51-7CD8-F17D3A5551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E4A44E0-C597-7E3C-5A87-A6EB9D3236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82994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6C81E6E-D466-084B-FB2B-0DC246E36D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05133F-A991-4F8B-BBDA-5CD637B59EE3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B7DB2E3-083F-7526-34E6-71F58B9970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F6BE456-22CF-D013-7744-474C98B49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323666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A3E9D2-4E6B-109C-70D3-F4B124AE64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B10352-EC58-05D0-9558-09F99EA4E7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26A494-858D-4504-15ED-015B2933FF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366E45-3B08-A47F-53CA-672EA0D7EF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89718-1F9A-4C1F-93AE-5036A61C958C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21104C-19E2-9FBA-06A6-B5B8060B87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1A717E-905D-14BE-45A3-0D255913E3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07407511"/>
      </p:ext>
    </p:extLst>
  </p:cSld>
  <p:clrMapOvr>
    <a:masterClrMapping/>
  </p:clrMapOvr>
  <p:hf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866EC7-3571-5D0D-7DA6-6FB5B14616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0796F35-17A6-373F-CA9F-72219132088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C8F544-6753-7FD2-4656-8FC4952DFA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CD093C-B7E6-2F57-907F-1BA086A2F3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EC115-7E0C-4614-A58F-812CE94E8367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F13D6C-88E5-B8F7-A8E6-024CFE0609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E5C75C-2C1C-6975-C626-E19FDB7388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74333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515729D-8659-B45E-6F8A-163E8BD1CF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912099-9171-D10F-8787-111336FD60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6BC007-2AF8-E33D-EBFE-74892B5046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189718-1F9A-4C1F-93AE-5036A61C958C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05EBA0-4D11-2F7F-5CFB-96ABC6B950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50EFBE-24A9-7072-FDA6-CE5F1E7178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048638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71" r:id="rId2"/>
    <p:sldLayoutId id="2147483672" r:id="rId3"/>
    <p:sldLayoutId id="2147483673" r:id="rId4"/>
    <p:sldLayoutId id="2147483674" r:id="rId5"/>
    <p:sldLayoutId id="2147483675" r:id="rId6"/>
    <p:sldLayoutId id="2147483676" r:id="rId7"/>
    <p:sldLayoutId id="2147483677" r:id="rId8"/>
    <p:sldLayoutId id="2147483678" r:id="rId9"/>
    <p:sldLayoutId id="2147483679" r:id="rId10"/>
    <p:sldLayoutId id="2147483680" r:id="rId11"/>
    <p:sldLayoutId id="2147483681" r:id="rId12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0EAA2732-5350-4D10-BDCD-F71EFA22518E}"/>
              </a:ext>
            </a:extLst>
          </p:cNvPr>
          <p:cNvSpPr txBox="1">
            <a:spLocks/>
          </p:cNvSpPr>
          <p:nvPr/>
        </p:nvSpPr>
        <p:spPr>
          <a:xfrm>
            <a:off x="2735013" y="163778"/>
            <a:ext cx="5976329" cy="6463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120000"/>
              </a:lnSpc>
              <a:spcBef>
                <a:spcPts val="1000"/>
              </a:spcBef>
              <a:buClr>
                <a:schemeClr val="tx1"/>
              </a:buClr>
              <a:buFont typeface="Arial" panose="020B0604020202020204" pitchFamily="34" charset="0"/>
              <a:buChar char="•"/>
              <a:defRPr sz="2000" kern="1200" cap="all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120000"/>
              </a:lnSpc>
              <a:spcBef>
                <a:spcPts val="500"/>
              </a:spcBef>
              <a:buClr>
                <a:schemeClr val="tx1"/>
              </a:buClr>
              <a:buFont typeface="Arial" panose="020B0604020202020204" pitchFamily="34" charset="0"/>
              <a:buChar char="•"/>
              <a:defRPr sz="1800" kern="1200" cap="all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120000"/>
              </a:lnSpc>
              <a:spcBef>
                <a:spcPts val="500"/>
              </a:spcBef>
              <a:buClr>
                <a:schemeClr val="tx1"/>
              </a:buClr>
              <a:buFont typeface="Arial" panose="020B0604020202020204" pitchFamily="34" charset="0"/>
              <a:buChar char="•"/>
              <a:defRPr sz="1600" kern="1200" cap="all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120000"/>
              </a:lnSpc>
              <a:spcBef>
                <a:spcPts val="500"/>
              </a:spcBef>
              <a:buClr>
                <a:schemeClr val="tx1"/>
              </a:buClr>
              <a:buFont typeface="Arial" panose="020B0604020202020204" pitchFamily="34" charset="0"/>
              <a:buChar char="•"/>
              <a:defRPr sz="1400" kern="1200" cap="all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120000"/>
              </a:lnSpc>
              <a:spcBef>
                <a:spcPts val="500"/>
              </a:spcBef>
              <a:buClr>
                <a:schemeClr val="tx1"/>
              </a:buClr>
              <a:buFont typeface="Arial" panose="020B0604020202020204" pitchFamily="34" charset="0"/>
              <a:buChar char="•"/>
              <a:defRPr sz="1400" kern="1200" cap="all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120000"/>
              </a:lnSpc>
              <a:spcBef>
                <a:spcPts val="500"/>
              </a:spcBef>
              <a:buClr>
                <a:schemeClr val="tx1"/>
              </a:buClr>
              <a:buFont typeface="Arial" panose="020B0604020202020204" pitchFamily="34" charset="0"/>
              <a:buChar char="•"/>
              <a:defRPr sz="1400" kern="1200" cap="all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120000"/>
              </a:lnSpc>
              <a:spcBef>
                <a:spcPts val="500"/>
              </a:spcBef>
              <a:buClr>
                <a:schemeClr val="tx1"/>
              </a:buClr>
              <a:buFont typeface="Arial" panose="020B0604020202020204" pitchFamily="34" charset="0"/>
              <a:buChar char="•"/>
              <a:defRPr sz="1400" kern="1200" cap="all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120000"/>
              </a:lnSpc>
              <a:spcBef>
                <a:spcPts val="500"/>
              </a:spcBef>
              <a:buClr>
                <a:schemeClr val="tx1"/>
              </a:buClr>
              <a:buFont typeface="Arial" panose="020B0604020202020204" pitchFamily="34" charset="0"/>
              <a:buChar char="•"/>
              <a:defRPr sz="1400" kern="1200" cap="all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120000"/>
              </a:lnSpc>
              <a:spcBef>
                <a:spcPts val="500"/>
              </a:spcBef>
              <a:buClr>
                <a:schemeClr val="tx1"/>
              </a:buClr>
              <a:buFont typeface="Arial" panose="020B0604020202020204" pitchFamily="34" charset="0"/>
              <a:buChar char="•"/>
              <a:defRPr sz="1400" kern="1200" cap="all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9pPr>
          </a:lstStyle>
          <a:p>
            <a:pPr marL="457200" lvl="1" indent="-400050">
              <a:buNone/>
            </a:pPr>
            <a:r>
              <a:rPr lang="en-US" sz="3200" cap="none" dirty="0">
                <a:solidFill>
                  <a:schemeClr val="tx2">
                    <a:lumMod val="50000"/>
                  </a:schemeClr>
                </a:solidFill>
              </a:rPr>
              <a:t>Molecular marker (SSR) evaluation</a:t>
            </a:r>
            <a:endParaRPr lang="en-US" sz="2800" cap="none" dirty="0">
              <a:solidFill>
                <a:schemeClr val="tx2">
                  <a:lumMod val="50000"/>
                </a:schemeClr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6322EE5-82E9-4F68-8948-4A58CAEBB4CD}"/>
              </a:ext>
            </a:extLst>
          </p:cNvPr>
          <p:cNvSpPr txBox="1"/>
          <p:nvPr/>
        </p:nvSpPr>
        <p:spPr>
          <a:xfrm>
            <a:off x="5405949" y="898642"/>
            <a:ext cx="62242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atterns of the polymorphic SSR markers in the 6 individuals derived from the cross between CMS HA 291 and G11/1485.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531200" y="1599645"/>
            <a:ext cx="4524375" cy="2865372"/>
            <a:chOff x="8106399" y="2361787"/>
            <a:chExt cx="4524375" cy="2865372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210" t="29207" b="14709"/>
            <a:stretch/>
          </p:blipFill>
          <p:spPr>
            <a:xfrm>
              <a:off x="8106399" y="2361787"/>
              <a:ext cx="4524375" cy="2865372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8138110" y="2383979"/>
              <a:ext cx="4492663" cy="784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u="sng" dirty="0"/>
                <a:t>   ORS552    </a:t>
              </a:r>
              <a:r>
                <a:rPr lang="en-US" dirty="0"/>
                <a:t>  </a:t>
              </a:r>
              <a:r>
                <a:rPr lang="en-US" u="sng" dirty="0"/>
                <a:t>    ORS697    </a:t>
              </a:r>
              <a:r>
                <a:rPr lang="en-US" dirty="0"/>
                <a:t>  </a:t>
              </a:r>
              <a:r>
                <a:rPr lang="en-US" u="sng" dirty="0"/>
                <a:t>      ORS326     </a:t>
              </a:r>
            </a:p>
            <a:p>
              <a:endParaRPr lang="en-US" sz="900" dirty="0"/>
            </a:p>
            <a:p>
              <a:r>
                <a:rPr lang="en-US" sz="900" b="1" dirty="0"/>
                <a:t>F  M   F</a:t>
              </a:r>
              <a:r>
                <a:rPr lang="en-US" sz="900" b="1" baseline="-25000" dirty="0"/>
                <a:t>1   </a:t>
              </a:r>
              <a:r>
                <a:rPr lang="en-US" sz="900" b="1" dirty="0"/>
                <a:t>1   2  3   4   5   6       F  M  F</a:t>
              </a:r>
              <a:r>
                <a:rPr lang="en-US" sz="900" b="1" baseline="-25000" dirty="0"/>
                <a:t>1   </a:t>
              </a:r>
              <a:r>
                <a:rPr lang="en-US" sz="900" b="1" dirty="0"/>
                <a:t>1   2   3   4   5  6        F  M  F</a:t>
              </a:r>
              <a:r>
                <a:rPr lang="en-US" sz="900" b="1" baseline="-25000" dirty="0"/>
                <a:t>1  </a:t>
              </a:r>
              <a:r>
                <a:rPr lang="en-US" sz="900" b="1" dirty="0"/>
                <a:t>1   2    3   4   5  6</a:t>
              </a:r>
              <a:r>
                <a:rPr lang="en-US" sz="900" b="1" u="sng" dirty="0"/>
                <a:t> </a:t>
              </a:r>
            </a:p>
            <a:p>
              <a:endParaRPr lang="en-US" sz="900" u="sng" dirty="0"/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8C2F519A-F321-40AC-8054-7ED5F922ECC2}"/>
              </a:ext>
            </a:extLst>
          </p:cNvPr>
          <p:cNvSpPr txBox="1"/>
          <p:nvPr/>
        </p:nvSpPr>
        <p:spPr>
          <a:xfrm>
            <a:off x="491008" y="4525676"/>
            <a:ext cx="4591052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enotyping results of potential DH individuals derived from the cross between CMS HA 291 and G11/1485 using SSR primer pairs ORS 552, ORS697, and ORS326. F: Female (CMS HA 291); M: Male (G11/1485); F</a:t>
            </a:r>
            <a:r>
              <a:rPr lang="en-US" baseline="-25000" dirty="0"/>
              <a:t>1</a:t>
            </a:r>
            <a:r>
              <a:rPr lang="en-US" dirty="0"/>
              <a:t>: Hybrid; 1-6: six potential DH individuals. </a:t>
            </a:r>
          </a:p>
          <a:p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60CBBE8-B1EC-43B7-80AE-2AF29128BEE7}"/>
              </a:ext>
            </a:extLst>
          </p:cNvPr>
          <p:cNvSpPr txBox="1"/>
          <p:nvPr/>
        </p:nvSpPr>
        <p:spPr>
          <a:xfrm>
            <a:off x="5345656" y="6275079"/>
            <a:ext cx="597632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7475" indent="-117475"/>
            <a:r>
              <a:rPr lang="en-US" sz="1400" baseline="30000" dirty="0"/>
              <a:t>a</a:t>
            </a:r>
            <a:r>
              <a:rPr lang="en-US" sz="1400" dirty="0"/>
              <a:t> LG: linkage group.</a:t>
            </a:r>
          </a:p>
          <a:p>
            <a:r>
              <a:rPr lang="en-US" sz="1400" dirty="0"/>
              <a:t>* F: Female genotype; M: Male genotype; H: Hybrid genotype. </a:t>
            </a:r>
          </a:p>
          <a:p>
            <a:endParaRPr lang="en-US" sz="1400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5659646"/>
              </p:ext>
            </p:extLst>
          </p:nvPr>
        </p:nvGraphicFramePr>
        <p:xfrm>
          <a:off x="5433651" y="1567660"/>
          <a:ext cx="6119443" cy="470116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55631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5631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5631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5631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5631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5631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556313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556313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556313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556313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556313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</a:tblGrid>
              <a:tr h="30886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 dirty="0">
                          <a:effectLst/>
                        </a:rPr>
                        <a:t>Markers</a:t>
                      </a:r>
                      <a:endParaRPr lang="en-US" sz="1100" b="1" i="0" u="none" strike="noStrike" dirty="0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 err="1">
                          <a:effectLst/>
                        </a:rPr>
                        <a:t>LG</a:t>
                      </a:r>
                      <a:r>
                        <a:rPr lang="en-US" sz="1050" u="none" strike="noStrike" baseline="30000" dirty="0" err="1">
                          <a:effectLst/>
                        </a:rPr>
                        <a:t>a</a:t>
                      </a:r>
                      <a:endParaRPr lang="en-US" sz="1050" b="1" i="0" u="none" strike="noStrike" dirty="0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CMS HA 291</a:t>
                      </a:r>
                      <a:endParaRPr lang="en-US" sz="1000" b="0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G11/ 1485</a:t>
                      </a:r>
                      <a:endParaRPr lang="en-US" sz="1000" b="0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r>
                        <a:rPr lang="en-US" sz="1000" u="none" strike="noStrike" baseline="-25000">
                          <a:effectLst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3</a:t>
                      </a:r>
                      <a:endParaRPr lang="en-US" sz="1000" b="0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5</a:t>
                      </a:r>
                      <a:endParaRPr lang="en-US" sz="1000" b="0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6</a:t>
                      </a:r>
                      <a:endParaRPr lang="en-US" sz="1000" b="0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543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r>
                        <a:rPr lang="en-US" sz="1000" u="none" strike="noStrike" baseline="30000">
                          <a:effectLst/>
                        </a:rPr>
                        <a:t>*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552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925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447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777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674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366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546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1120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745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323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331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456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258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691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541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697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326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767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799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316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1086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1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008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499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6917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656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6111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ORS 297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H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w Cen MT" panose="020B0602020104020603" pitchFamily="34" charset="0"/>
                      </a:endParaRPr>
                    </a:p>
                  </a:txBody>
                  <a:tcPr marL="5894" marR="5894" marT="5894" marB="0" anchor="ctr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DE68C8C7-3A4B-5393-D1B0-574C3AA886C0}"/>
              </a:ext>
            </a:extLst>
          </p:cNvPr>
          <p:cNvSpPr txBox="1"/>
          <p:nvPr/>
        </p:nvSpPr>
        <p:spPr>
          <a:xfrm>
            <a:off x="0" y="-12722"/>
            <a:ext cx="2374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S1</a:t>
            </a:r>
          </a:p>
        </p:txBody>
      </p:sp>
    </p:spTree>
    <p:extLst>
      <p:ext uri="{BB962C8B-B14F-4D97-AF65-F5344CB8AC3E}">
        <p14:creationId xmlns:p14="http://schemas.microsoft.com/office/powerpoint/2010/main" val="37458178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311</TotalTime>
  <Words>465</Words>
  <Application>Microsoft Office PowerPoint</Application>
  <PresentationFormat>Widescreen</PresentationFormat>
  <Paragraphs>30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w Cen M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Hongxia - ARS</dc:creator>
  <cp:lastModifiedBy>Chao, Wun - REE-ARS</cp:lastModifiedBy>
  <cp:revision>272</cp:revision>
  <dcterms:created xsi:type="dcterms:W3CDTF">2018-02-23T17:16:05Z</dcterms:created>
  <dcterms:modified xsi:type="dcterms:W3CDTF">2023-05-22T18:39:00Z</dcterms:modified>
</cp:coreProperties>
</file>